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88" r:id="rId2"/>
  </p:sldIdLst>
  <p:sldSz cx="6840538" cy="9144000"/>
  <p:notesSz cx="7102475" cy="10234613"/>
  <p:defaultTextStyle>
    <a:defPPr>
      <a:defRPr lang="zh-TW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1">
          <p15:clr>
            <a:srgbClr val="A4A3A4"/>
          </p15:clr>
        </p15:guide>
        <p15:guide id="2" pos="215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4" name="作者" initials="A" lastIdx="0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6471" autoAdjust="0"/>
    <p:restoredTop sz="88300" autoAdjust="0"/>
  </p:normalViewPr>
  <p:slideViewPr>
    <p:cSldViewPr>
      <p:cViewPr>
        <p:scale>
          <a:sx n="100" d="100"/>
          <a:sy n="100" d="100"/>
        </p:scale>
        <p:origin x="-1614" y="252"/>
      </p:cViewPr>
      <p:guideLst>
        <p:guide orient="horz" pos="2881"/>
        <p:guide pos="215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1175"/>
          </a:xfrm>
          <a:prstGeom prst="rect">
            <a:avLst/>
          </a:prstGeom>
        </p:spPr>
        <p:txBody>
          <a:bodyPr vert="horz" lIns="99046" tIns="49525" rIns="99046" bIns="49525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4022725" y="0"/>
            <a:ext cx="3078163" cy="511175"/>
          </a:xfrm>
          <a:prstGeom prst="rect">
            <a:avLst/>
          </a:prstGeom>
        </p:spPr>
        <p:txBody>
          <a:bodyPr vert="horz" lIns="99046" tIns="49525" rIns="99046" bIns="49525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fld id="{21CFC365-D0C6-42F4-A081-2965E37B2B8D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16138" y="768350"/>
            <a:ext cx="28702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6" tIns="49525" rIns="99046" bIns="49525" rtlCol="0" anchor="ctr"/>
          <a:lstStyle/>
          <a:p>
            <a:pPr lvl="0"/>
            <a:endParaRPr lang="zh-TW" altLang="en-US" noProof="0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3250" cy="4605338"/>
          </a:xfrm>
          <a:prstGeom prst="rect">
            <a:avLst/>
          </a:prstGeom>
        </p:spPr>
        <p:txBody>
          <a:bodyPr vert="horz" lIns="99046" tIns="49525" rIns="99046" bIns="49525" rtlCol="0">
            <a:normAutofit/>
          </a:bodyPr>
          <a:lstStyle/>
          <a:p>
            <a:pPr lvl="0"/>
            <a:r>
              <a:rPr lang="zh-TW" altLang="en-US" noProof="0" smtClean="0"/>
              <a:t>按一下以編輯母片文字樣式</a:t>
            </a:r>
          </a:p>
          <a:p>
            <a:pPr lvl="1"/>
            <a:r>
              <a:rPr lang="zh-TW" altLang="en-US" noProof="0" smtClean="0"/>
              <a:t>第二層</a:t>
            </a:r>
          </a:p>
          <a:p>
            <a:pPr lvl="2"/>
            <a:r>
              <a:rPr lang="zh-TW" altLang="en-US" noProof="0" smtClean="0"/>
              <a:t>第三層</a:t>
            </a:r>
          </a:p>
          <a:p>
            <a:pPr lvl="3"/>
            <a:r>
              <a:rPr lang="zh-TW" altLang="en-US" noProof="0" smtClean="0"/>
              <a:t>第四層</a:t>
            </a:r>
          </a:p>
          <a:p>
            <a:pPr lvl="4"/>
            <a:r>
              <a:rPr lang="zh-TW" altLang="en-US" noProof="0" smtClean="0"/>
              <a:t>第五層</a:t>
            </a:r>
            <a:endParaRPr lang="zh-TW" altLang="en-US" noProof="0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1175"/>
          </a:xfrm>
          <a:prstGeom prst="rect">
            <a:avLst/>
          </a:prstGeom>
        </p:spPr>
        <p:txBody>
          <a:bodyPr vert="horz" lIns="99046" tIns="49525" rIns="99046" bIns="49525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4022725" y="9721850"/>
            <a:ext cx="3078163" cy="511175"/>
          </a:xfrm>
          <a:prstGeom prst="rect">
            <a:avLst/>
          </a:prstGeom>
        </p:spPr>
        <p:txBody>
          <a:bodyPr vert="horz" lIns="99046" tIns="49525" rIns="99046" bIns="49525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fld id="{FFD651FE-E64B-4C65-9191-6E2D995DF651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64092593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123" name="備忘稿版面配置區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5DEA9C05-BA36-4128-9B9D-369FE1D88E50}" type="slidenum">
              <a:rPr lang="zh-TW" altLang="en-US" smtClean="0"/>
              <a:pPr>
                <a:defRPr/>
              </a:pPr>
              <a:t>1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0911587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3041" y="2840577"/>
            <a:ext cx="5814457" cy="196003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6088" y="5181610"/>
            <a:ext cx="4788377" cy="23367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E2860F-ACAE-4F72-9BE3-B1F03C786237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CC69C-6B5C-4BD7-8233-4BEFD3996E96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E70C29-1405-4BF2-95E3-DDFB72D8549E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F894CD-EAD6-4E2E-9312-834843223177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249117" y="366189"/>
            <a:ext cx="1939340" cy="780203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31097" y="366189"/>
            <a:ext cx="5704011" cy="780203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C8A3AF-262B-41C0-871B-3C5444BDF27F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178684-E5FB-4E60-944F-07CAB806DDFE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86ED11-02D4-4C6D-A702-A33860265E0C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3A4938-CFCC-414D-B3EA-BBD4E6AAF8F4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0356" y="5875871"/>
            <a:ext cx="5814457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0356" y="3875629"/>
            <a:ext cx="5814457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6BB3B7-D48B-4A12-9226-DBE436108D55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2BE3E7-09EE-477E-AEC2-1A266EC6989E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31098" y="2133611"/>
            <a:ext cx="3821676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366784" y="2133611"/>
            <a:ext cx="3821676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18FB6E-C9C0-4896-8B91-3125247470F3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AA86E5-236B-435B-86D4-17E1E8F132A1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027" y="366183"/>
            <a:ext cx="6156484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027" y="2046820"/>
            <a:ext cx="302242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027" y="2899836"/>
            <a:ext cx="302242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74909" y="2046820"/>
            <a:ext cx="302361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74909" y="2899836"/>
            <a:ext cx="302361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2E947E-286A-43DA-9AAE-F30859FB4487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5431E7-E5FC-4A2F-A680-AD3827965E1E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AB22BB-221A-4301-89D8-44F69F5A5233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9B6706-212F-4DA5-AF0B-157D13A4BC97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7F8AAE-8A9F-4A47-8B7E-5693F8140615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9C8E3A-9EBD-4093-AFCB-E4888016FBD3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029" y="364070"/>
            <a:ext cx="2250490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74460" y="364072"/>
            <a:ext cx="3824051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029" y="1913476"/>
            <a:ext cx="2250490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D1764-5228-4896-9B37-E6BCD1F0DB9C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62C6E4-9B71-4C02-80DF-2537DB397A3E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0793" y="6400805"/>
            <a:ext cx="4104323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0793" y="817033"/>
            <a:ext cx="4104323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0793" y="7156458"/>
            <a:ext cx="4104323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6D72A8-58B2-41B4-B443-010DA8E10759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ACFC4-9774-45A3-BF92-4927EB8E48BF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標題版面配置區 1"/>
          <p:cNvSpPr>
            <a:spLocks noGrp="1"/>
          </p:cNvSpPr>
          <p:nvPr>
            <p:ph type="title"/>
          </p:nvPr>
        </p:nvSpPr>
        <p:spPr bwMode="auto">
          <a:xfrm>
            <a:off x="341313" y="366713"/>
            <a:ext cx="6157912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1027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341313" y="2133600"/>
            <a:ext cx="6157912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1313" y="8475663"/>
            <a:ext cx="159702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B660C54-6CF9-462C-AED0-1FC282F6E250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36800" y="8475663"/>
            <a:ext cx="2166938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02200" y="8475663"/>
            <a:ext cx="159702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38C9392-8AEA-46D0-9BB4-6FC0C7F67EC9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043856370"/>
              </p:ext>
            </p:extLst>
          </p:nvPr>
        </p:nvGraphicFramePr>
        <p:xfrm>
          <a:off x="393700" y="4286250"/>
          <a:ext cx="6046853" cy="4396144"/>
        </p:xfrm>
        <a:graphic>
          <a:graphicData uri="http://schemas.openxmlformats.org/drawingml/2006/table">
            <a:tbl>
              <a:tblPr/>
              <a:tblGrid>
                <a:gridCol w="855075"/>
                <a:gridCol w="1122284"/>
                <a:gridCol w="916797"/>
                <a:gridCol w="1047279"/>
                <a:gridCol w="1058139"/>
                <a:gridCol w="1047279"/>
              </a:tblGrid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ell line</a:t>
                      </a:r>
                      <a:r>
                        <a:rPr lang="zh-TW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TCD (</a:t>
                      </a:r>
                      <a:r>
                        <a:rPr lang="en-US" sz="1200" b="1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0 nM</a:t>
                      </a: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)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subG</a:t>
                      </a:r>
                      <a:r>
                        <a:rPr lang="en-US" sz="1200" b="1" kern="100" baseline="-250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G</a:t>
                      </a:r>
                      <a:r>
                        <a:rPr lang="en-US" sz="1200" b="1" kern="100" baseline="-250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S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G</a:t>
                      </a:r>
                      <a:r>
                        <a:rPr lang="en-US" sz="1200" b="1" kern="100" baseline="-250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</a:t>
                      </a: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/M</a:t>
                      </a:r>
                      <a:endParaRPr lang="zh-TW" sz="1200" kern="10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401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b="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ep-J5</a:t>
                      </a:r>
                      <a:endParaRPr lang="zh-TW" sz="1200" b="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6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8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6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1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8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4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8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3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2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401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1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9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8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9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6.4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0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5.3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12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4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7.7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8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7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7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2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0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6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6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70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TW" sz="1200" kern="10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18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0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0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6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9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TW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0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5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91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24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1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5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1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7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8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4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9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3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9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5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97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-48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 smtClean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1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1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3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4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4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7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8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9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6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4.7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81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3.0%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401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b="0" dirty="0" smtClean="0">
                          <a:latin typeface="Times New Roman" pitchFamily="18" charset="0"/>
                          <a:cs typeface="Times New Roman" pitchFamily="18" charset="0"/>
                        </a:rPr>
                        <a:t>Mahlavu</a:t>
                      </a:r>
                      <a:endParaRPr lang="zh-TW" sz="1200" b="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6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6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5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1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8.7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1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6.2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7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401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8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0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8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8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2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5.8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9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2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12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5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1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5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9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2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5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2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2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8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8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8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63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0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TW" sz="1200" kern="10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18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4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9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9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5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6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TW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1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5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5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90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8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-24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7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1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9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1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9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4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8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3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95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7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 -48</a:t>
                      </a:r>
                      <a:r>
                        <a:rPr lang="en-US" sz="1200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</a:t>
                      </a:r>
                      <a:endParaRPr lang="zh-TW" sz="1200" kern="100" dirty="0" smtClean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5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5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56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0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3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7.4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9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9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82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8 h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72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3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4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6.6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5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7.5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70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3.7</a:t>
                      </a:r>
                      <a:endParaRPr lang="zh-TW" alt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00769532"/>
              </p:ext>
            </p:extLst>
          </p:nvPr>
        </p:nvGraphicFramePr>
        <p:xfrm>
          <a:off x="393700" y="1836738"/>
          <a:ext cx="6046853" cy="2020761"/>
        </p:xfrm>
        <a:graphic>
          <a:graphicData uri="http://schemas.openxmlformats.org/drawingml/2006/table">
            <a:tbl>
              <a:tblPr/>
              <a:tblGrid>
                <a:gridCol w="855075"/>
                <a:gridCol w="1122284"/>
                <a:gridCol w="916797"/>
                <a:gridCol w="1047279"/>
                <a:gridCol w="1058139"/>
                <a:gridCol w="1047279"/>
              </a:tblGrid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ell line</a:t>
                      </a:r>
                      <a:r>
                        <a:rPr lang="zh-TW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　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TCD (24</a:t>
                      </a:r>
                      <a:r>
                        <a:rPr lang="en-US" sz="1200" b="1" kern="100" baseline="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 </a:t>
                      </a: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)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subG</a:t>
                      </a:r>
                      <a:r>
                        <a:rPr lang="en-US" sz="1200" b="1" kern="100" baseline="-250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G</a:t>
                      </a:r>
                      <a:r>
                        <a:rPr lang="en-US" sz="1200" b="1" kern="100" baseline="-250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</a:t>
                      </a:r>
                      <a:endParaRPr lang="zh-TW" sz="1200" kern="100" baseline="-250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S</a:t>
                      </a:r>
                      <a:endParaRPr lang="zh-TW" sz="1200" kern="10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G</a:t>
                      </a:r>
                      <a:r>
                        <a:rPr lang="en-US" sz="1200" b="1" kern="100" baseline="-250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</a:t>
                      </a:r>
                      <a:r>
                        <a:rPr lang="en-US" sz="1200" b="1" kern="100" dirty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/M</a:t>
                      </a:r>
                      <a:endParaRPr lang="zh-TW" sz="1200" kern="10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b="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Hep-J5</a:t>
                      </a:r>
                      <a:endParaRPr lang="zh-TW" sz="1200" b="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7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3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9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9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0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7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1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 nM 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8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4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2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4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1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2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7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3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0 nM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0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6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.9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4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8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93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7.9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0 nM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4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3.5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0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6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7.5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5.3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92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4.9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b="0" dirty="0" smtClean="0">
                          <a:latin typeface="Times New Roman" pitchFamily="18" charset="0"/>
                          <a:cs typeface="Times New Roman" pitchFamily="18" charset="0"/>
                        </a:rPr>
                        <a:t>Mahlavu</a:t>
                      </a:r>
                      <a:endParaRPr lang="zh-TW" sz="1200" b="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Control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7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7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5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2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3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0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0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5 nM 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.3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2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4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0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6295" marR="6295" marT="1122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2.8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4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2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9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10 nM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33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3.3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6.0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6.2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4.6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7.0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89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3.2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452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20 nM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7.4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1.1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0.2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0.2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8.7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7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</a:rPr>
                        <a:t>91.1 </a:t>
                      </a:r>
                      <a:r>
                        <a:rPr lang="en-US" altLang="zh-TW" sz="1200" kern="100" dirty="0" smtClean="0">
                          <a:latin typeface="Times New Roman" pitchFamily="18" charset="0"/>
                          <a:ea typeface="標楷體" pitchFamily="65" charset="-120"/>
                          <a:cs typeface="Times New Roman" pitchFamily="18" charset="0"/>
                          <a:sym typeface="Symbol"/>
                        </a:rPr>
                        <a:t> 2.9</a:t>
                      </a:r>
                      <a:endParaRPr lang="zh-TW" sz="1200" kern="100" dirty="0">
                        <a:latin typeface="Times New Roman" pitchFamily="18" charset="0"/>
                        <a:ea typeface="標楷體" pitchFamily="65" charset="-120"/>
                        <a:cs typeface="Times New Roman" pitchFamily="18" charset="0"/>
                      </a:endParaRPr>
                    </a:p>
                  </a:txBody>
                  <a:tcPr marL="3357" marR="3357" marT="5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240" name="矩形 5"/>
          <p:cNvSpPr>
            <a:spLocks noChangeArrowheads="1"/>
          </p:cNvSpPr>
          <p:nvPr/>
        </p:nvSpPr>
        <p:spPr bwMode="auto">
          <a:xfrm>
            <a:off x="827981" y="1130300"/>
            <a:ext cx="54498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Table. 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Effect of TCD on G</a:t>
            </a:r>
            <a:r>
              <a:rPr lang="en-US" altLang="zh-TW" sz="12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/M </a:t>
            </a:r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phase arrest and 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apoptosis</a:t>
            </a:r>
            <a:endParaRPr lang="zh-TW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41" name="Rectangle 1"/>
          <p:cNvSpPr>
            <a:spLocks noChangeArrowheads="1"/>
          </p:cNvSpPr>
          <p:nvPr/>
        </p:nvSpPr>
        <p:spPr bwMode="auto">
          <a:xfrm>
            <a:off x="84138" y="1543457"/>
            <a:ext cx="21932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(A) Concentration 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dependence</a:t>
            </a:r>
            <a:endParaRPr lang="en-US" altLang="zh-TW" dirty="0"/>
          </a:p>
        </p:txBody>
      </p:sp>
      <p:sp>
        <p:nvSpPr>
          <p:cNvPr id="2242" name="Rectangle 1"/>
          <p:cNvSpPr>
            <a:spLocks noChangeArrowheads="1"/>
          </p:cNvSpPr>
          <p:nvPr/>
        </p:nvSpPr>
        <p:spPr bwMode="auto">
          <a:xfrm>
            <a:off x="88900" y="3992563"/>
            <a:ext cx="12319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(B) Time course</a:t>
            </a:r>
            <a:endParaRPr lang="en-US" altLang="zh-TW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9</Words>
  <Application>Microsoft Office PowerPoint</Application>
  <PresentationFormat>自訂</PresentationFormat>
  <Paragraphs>164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5-04-15T10:40:08Z</dcterms:created>
  <dcterms:modified xsi:type="dcterms:W3CDTF">2015-08-10T01:50:49Z</dcterms:modified>
</cp:coreProperties>
</file>